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686925"/>
  <p:defaultTextStyle>
    <a:defPPr>
      <a:defRPr lang="it-IT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40" d="100"/>
          <a:sy n="140" d="100"/>
        </p:scale>
        <p:origin x="-168" y="61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campo%20e%20dati%20fenotipici\dati%20climatici%202011%20e%20201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G:\campo%20e%20dati%20fenotipici\dati%20climatici%202011%20e%202012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G:\campo%20e%20dati%20fenotipici\dati%20climatici%202011%20e%20201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lineChart>
        <c:grouping val="standard"/>
        <c:varyColors val="0"/>
        <c:ser>
          <c:idx val="1"/>
          <c:order val="0"/>
          <c:tx>
            <c:strRef>
              <c:f>temperatures!$BO$1</c:f>
              <c:strCache>
                <c:ptCount val="1"/>
                <c:pt idx="0">
                  <c:v>max  2011</c:v>
                </c:pt>
              </c:strCache>
            </c:strRef>
          </c:tx>
          <c:spPr>
            <a:ln>
              <a:solidFill>
                <a:sysClr val="windowText" lastClr="000000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marker>
          <c:val>
            <c:numRef>
              <c:f>temperatures!$BO$2:$BO$13</c:f>
              <c:numCache>
                <c:formatCode>General</c:formatCode>
                <c:ptCount val="12"/>
                <c:pt idx="0">
                  <c:v>30.757142857142849</c:v>
                </c:pt>
                <c:pt idx="1">
                  <c:v>28.771428571428569</c:v>
                </c:pt>
                <c:pt idx="2">
                  <c:v>30.971428571428561</c:v>
                </c:pt>
                <c:pt idx="3">
                  <c:v>27.528571428571428</c:v>
                </c:pt>
                <c:pt idx="4">
                  <c:v>26.714285714285719</c:v>
                </c:pt>
                <c:pt idx="5">
                  <c:v>30.085714285714271</c:v>
                </c:pt>
                <c:pt idx="6">
                  <c:v>28.385714285714279</c:v>
                </c:pt>
                <c:pt idx="7">
                  <c:v>31.157142857142858</c:v>
                </c:pt>
                <c:pt idx="8">
                  <c:v>34.871428571428538</c:v>
                </c:pt>
                <c:pt idx="9">
                  <c:v>29.971428571428572</c:v>
                </c:pt>
                <c:pt idx="10">
                  <c:v>27.24285714285714</c:v>
                </c:pt>
                <c:pt idx="11">
                  <c:v>30.042857142857098</c:v>
                </c:pt>
              </c:numCache>
            </c:numRef>
          </c:val>
          <c:smooth val="0"/>
        </c:ser>
        <c:ser>
          <c:idx val="2"/>
          <c:order val="1"/>
          <c:tx>
            <c:strRef>
              <c:f>temperatures!$BP$1</c:f>
              <c:strCache>
                <c:ptCount val="1"/>
                <c:pt idx="0">
                  <c:v>max  2012</c:v>
                </c:pt>
              </c:strCache>
            </c:strRef>
          </c:tx>
          <c:spPr>
            <a:ln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triangle"/>
            <c:size val="7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c:spPr>
          </c:marker>
          <c:val>
            <c:numRef>
              <c:f>temperatures!$BP$2:$BP$13</c:f>
              <c:numCache>
                <c:formatCode>General</c:formatCode>
                <c:ptCount val="12"/>
                <c:pt idx="0">
                  <c:v>33.17142857142855</c:v>
                </c:pt>
                <c:pt idx="1">
                  <c:v>31.914285714285722</c:v>
                </c:pt>
                <c:pt idx="2">
                  <c:v>31.5</c:v>
                </c:pt>
                <c:pt idx="3">
                  <c:v>30.885714285714279</c:v>
                </c:pt>
                <c:pt idx="4">
                  <c:v>34</c:v>
                </c:pt>
                <c:pt idx="5">
                  <c:v>34.114285714285707</c:v>
                </c:pt>
                <c:pt idx="6">
                  <c:v>32.328571428571429</c:v>
                </c:pt>
                <c:pt idx="7">
                  <c:v>35.785714285714278</c:v>
                </c:pt>
                <c:pt idx="8">
                  <c:v>32.585714285714268</c:v>
                </c:pt>
                <c:pt idx="9">
                  <c:v>25.48571428571427</c:v>
                </c:pt>
                <c:pt idx="10">
                  <c:v>31.28333333333331</c:v>
                </c:pt>
              </c:numCache>
            </c:numRef>
          </c:val>
          <c:smooth val="0"/>
        </c:ser>
        <c:ser>
          <c:idx val="3"/>
          <c:order val="2"/>
          <c:tx>
            <c:strRef>
              <c:f>temperatures!$BQ$1</c:f>
              <c:strCache>
                <c:ptCount val="1"/>
                <c:pt idx="0">
                  <c:v>min  2011</c:v>
                </c:pt>
              </c:strCache>
            </c:strRef>
          </c:tx>
          <c:spPr>
            <a:ln>
              <a:solidFill>
                <a:sysClr val="windowText" lastClr="000000"/>
              </a:solidFill>
            </a:ln>
          </c:spPr>
          <c:marker>
            <c:spPr>
              <a:ln>
                <a:solidFill>
                  <a:sysClr val="windowText" lastClr="000000"/>
                </a:solidFill>
              </a:ln>
            </c:spPr>
          </c:marker>
          <c:val>
            <c:numRef>
              <c:f>temperatures!$BQ$2:$BQ$13</c:f>
              <c:numCache>
                <c:formatCode>General</c:formatCode>
                <c:ptCount val="12"/>
                <c:pt idx="0">
                  <c:v>18.599999999999991</c:v>
                </c:pt>
                <c:pt idx="1">
                  <c:v>18.62857142857143</c:v>
                </c:pt>
                <c:pt idx="2">
                  <c:v>19.61428571428571</c:v>
                </c:pt>
                <c:pt idx="3">
                  <c:v>16.842857142857149</c:v>
                </c:pt>
                <c:pt idx="4">
                  <c:v>15.55714285714286</c:v>
                </c:pt>
                <c:pt idx="5">
                  <c:v>17.585714285714271</c:v>
                </c:pt>
                <c:pt idx="6">
                  <c:v>17.3</c:v>
                </c:pt>
                <c:pt idx="7">
                  <c:v>18.714285714285719</c:v>
                </c:pt>
                <c:pt idx="8">
                  <c:v>20.828571428571429</c:v>
                </c:pt>
                <c:pt idx="9">
                  <c:v>16.5</c:v>
                </c:pt>
                <c:pt idx="10">
                  <c:v>18</c:v>
                </c:pt>
                <c:pt idx="11">
                  <c:v>17.51428571428572</c:v>
                </c:pt>
              </c:numCache>
            </c:numRef>
          </c:val>
          <c:smooth val="0"/>
        </c:ser>
        <c:ser>
          <c:idx val="4"/>
          <c:order val="3"/>
          <c:tx>
            <c:strRef>
              <c:f>temperatures!$BR$1</c:f>
              <c:strCache>
                <c:ptCount val="1"/>
                <c:pt idx="0">
                  <c:v>min  2012</c:v>
                </c:pt>
              </c:strCache>
            </c:strRef>
          </c:tx>
          <c:spPr>
            <a:ln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c:spPr>
          </c:marker>
          <c:val>
            <c:numRef>
              <c:f>temperatures!$BR$2:$BR$13</c:f>
              <c:numCache>
                <c:formatCode>General</c:formatCode>
                <c:ptCount val="12"/>
                <c:pt idx="0">
                  <c:v>20.714285714285719</c:v>
                </c:pt>
                <c:pt idx="1">
                  <c:v>19.55714285714285</c:v>
                </c:pt>
                <c:pt idx="2">
                  <c:v>18.74285714285714</c:v>
                </c:pt>
                <c:pt idx="3">
                  <c:v>17.328571428571429</c:v>
                </c:pt>
                <c:pt idx="4">
                  <c:v>19.599999999999991</c:v>
                </c:pt>
                <c:pt idx="5">
                  <c:v>19.114285714285721</c:v>
                </c:pt>
                <c:pt idx="6">
                  <c:v>19.5</c:v>
                </c:pt>
                <c:pt idx="7">
                  <c:v>21.87142857142857</c:v>
                </c:pt>
                <c:pt idx="8">
                  <c:v>18.87142857142857</c:v>
                </c:pt>
                <c:pt idx="9">
                  <c:v>14.857142857142859</c:v>
                </c:pt>
                <c:pt idx="10">
                  <c:v>14.1666666666666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9740928"/>
        <c:axId val="39742848"/>
      </c:lineChart>
      <c:catAx>
        <c:axId val="3974092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lang="it-IT" sz="11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39742848"/>
        <c:crosses val="autoZero"/>
        <c:auto val="1"/>
        <c:lblAlgn val="ctr"/>
        <c:lblOffset val="100"/>
        <c:noMultiLvlLbl val="0"/>
      </c:catAx>
      <c:valAx>
        <c:axId val="39742848"/>
        <c:scaling>
          <c:orientation val="minMax"/>
          <c:min val="1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it-IT" sz="11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39740928"/>
        <c:crosses val="autoZero"/>
        <c:crossBetween val="between"/>
      </c:valAx>
    </c:plotArea>
    <c:legend>
      <c:legendPos val="r"/>
      <c:layout/>
      <c:overlay val="0"/>
      <c:spPr>
        <a:ln>
          <a:noFill/>
        </a:ln>
      </c:spPr>
      <c:txPr>
        <a:bodyPr/>
        <a:lstStyle/>
        <a:p>
          <a:pPr>
            <a:defRPr lang="it-IT" sz="1050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lineChart>
        <c:grouping val="standard"/>
        <c:varyColors val="0"/>
        <c:ser>
          <c:idx val="1"/>
          <c:order val="0"/>
          <c:tx>
            <c:strRef>
              <c:f>'relative humidity'!$BO$1</c:f>
              <c:strCache>
                <c:ptCount val="1"/>
                <c:pt idx="0">
                  <c:v>max 2011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val>
            <c:numRef>
              <c:f>'relative humidity'!$BO$2:$BO$13</c:f>
              <c:numCache>
                <c:formatCode>General</c:formatCode>
                <c:ptCount val="12"/>
                <c:pt idx="0">
                  <c:v>83.142857142857096</c:v>
                </c:pt>
                <c:pt idx="1">
                  <c:v>78.571428571428541</c:v>
                </c:pt>
                <c:pt idx="2">
                  <c:v>87.285714285714306</c:v>
                </c:pt>
                <c:pt idx="3">
                  <c:v>85.857142857142847</c:v>
                </c:pt>
                <c:pt idx="4">
                  <c:v>91.285714285714306</c:v>
                </c:pt>
                <c:pt idx="5">
                  <c:v>88.571428571428541</c:v>
                </c:pt>
                <c:pt idx="6">
                  <c:v>84.142857142857096</c:v>
                </c:pt>
                <c:pt idx="7">
                  <c:v>82.142857142857096</c:v>
                </c:pt>
                <c:pt idx="8">
                  <c:v>82</c:v>
                </c:pt>
                <c:pt idx="9">
                  <c:v>77.285714285714306</c:v>
                </c:pt>
                <c:pt idx="10">
                  <c:v>96</c:v>
                </c:pt>
                <c:pt idx="11">
                  <c:v>92</c:v>
                </c:pt>
              </c:numCache>
            </c:numRef>
          </c:val>
          <c:smooth val="0"/>
        </c:ser>
        <c:ser>
          <c:idx val="2"/>
          <c:order val="1"/>
          <c:tx>
            <c:strRef>
              <c:f>'relative humidity'!$BP$1</c:f>
              <c:strCache>
                <c:ptCount val="1"/>
                <c:pt idx="0">
                  <c:v>max 2012</c:v>
                </c:pt>
              </c:strCache>
            </c:strRef>
          </c:tx>
          <c:spPr>
            <a:ln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c:spPr>
          </c:marker>
          <c:val>
            <c:numRef>
              <c:f>'relative humidity'!$BP$2:$BP$13</c:f>
              <c:numCache>
                <c:formatCode>General</c:formatCode>
                <c:ptCount val="12"/>
                <c:pt idx="0">
                  <c:v>74.142857142857096</c:v>
                </c:pt>
                <c:pt idx="1">
                  <c:v>80.428571428571402</c:v>
                </c:pt>
                <c:pt idx="2">
                  <c:v>70.285714285714306</c:v>
                </c:pt>
                <c:pt idx="3">
                  <c:v>80.714285714285722</c:v>
                </c:pt>
                <c:pt idx="4">
                  <c:v>79.857142857142847</c:v>
                </c:pt>
                <c:pt idx="5">
                  <c:v>75.714285714285722</c:v>
                </c:pt>
                <c:pt idx="6">
                  <c:v>70.142857142857096</c:v>
                </c:pt>
                <c:pt idx="7">
                  <c:v>69.428571428571402</c:v>
                </c:pt>
                <c:pt idx="8">
                  <c:v>69.857142857142847</c:v>
                </c:pt>
                <c:pt idx="9">
                  <c:v>98.142857142857096</c:v>
                </c:pt>
                <c:pt idx="10">
                  <c:v>99.3333333333333</c:v>
                </c:pt>
              </c:numCache>
            </c:numRef>
          </c:val>
          <c:smooth val="0"/>
        </c:ser>
        <c:ser>
          <c:idx val="3"/>
          <c:order val="2"/>
          <c:tx>
            <c:strRef>
              <c:f>'relative humidity'!$BQ$1</c:f>
              <c:strCache>
                <c:ptCount val="1"/>
                <c:pt idx="0">
                  <c:v>min 2011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val>
            <c:numRef>
              <c:f>'relative humidity'!$BQ$2:$BQ$13</c:f>
              <c:numCache>
                <c:formatCode>General</c:formatCode>
                <c:ptCount val="12"/>
                <c:pt idx="0">
                  <c:v>37</c:v>
                </c:pt>
                <c:pt idx="1">
                  <c:v>38.428571428571431</c:v>
                </c:pt>
                <c:pt idx="2">
                  <c:v>40.428571428571431</c:v>
                </c:pt>
                <c:pt idx="3">
                  <c:v>36.714285714285722</c:v>
                </c:pt>
                <c:pt idx="4">
                  <c:v>34.85714285714284</c:v>
                </c:pt>
                <c:pt idx="5">
                  <c:v>36.85714285714284</c:v>
                </c:pt>
                <c:pt idx="6">
                  <c:v>38.142857142857153</c:v>
                </c:pt>
                <c:pt idx="7">
                  <c:v>36.285714285714278</c:v>
                </c:pt>
                <c:pt idx="8">
                  <c:v>29.714285714285719</c:v>
                </c:pt>
                <c:pt idx="9">
                  <c:v>29.857142857142851</c:v>
                </c:pt>
                <c:pt idx="10">
                  <c:v>52.285714285714278</c:v>
                </c:pt>
                <c:pt idx="11">
                  <c:v>39.285714285714278</c:v>
                </c:pt>
              </c:numCache>
            </c:numRef>
          </c:val>
          <c:smooth val="0"/>
        </c:ser>
        <c:ser>
          <c:idx val="4"/>
          <c:order val="3"/>
          <c:tx>
            <c:strRef>
              <c:f>'relative humidity'!$BR$1</c:f>
              <c:strCache>
                <c:ptCount val="1"/>
                <c:pt idx="0">
                  <c:v>min 2012</c:v>
                </c:pt>
              </c:strCache>
            </c:strRef>
          </c:tx>
          <c:spPr>
            <a:ln>
              <a:solidFill>
                <a:schemeClr val="tx1">
                  <a:lumMod val="50000"/>
                  <a:lumOff val="50000"/>
                </a:schemeClr>
              </a:solidFill>
            </a:ln>
          </c:spPr>
          <c:marker>
            <c:symbol val="circle"/>
            <c:size val="7"/>
            <c:spPr>
              <a:solidFill>
                <a:schemeClr val="tx1">
                  <a:lumMod val="50000"/>
                  <a:lumOff val="50000"/>
                </a:schemeClr>
              </a:solidFill>
            </c:spPr>
          </c:marker>
          <c:val>
            <c:numRef>
              <c:f>'relative humidity'!$BR$2:$BR$13</c:f>
              <c:numCache>
                <c:formatCode>General</c:formatCode>
                <c:ptCount val="12"/>
                <c:pt idx="0">
                  <c:v>34</c:v>
                </c:pt>
                <c:pt idx="1">
                  <c:v>36.428571428571431</c:v>
                </c:pt>
                <c:pt idx="2">
                  <c:v>29.428571428571431</c:v>
                </c:pt>
                <c:pt idx="3">
                  <c:v>34.142857142857153</c:v>
                </c:pt>
                <c:pt idx="4">
                  <c:v>33.142857142857153</c:v>
                </c:pt>
                <c:pt idx="5">
                  <c:v>30.142857142857149</c:v>
                </c:pt>
                <c:pt idx="6">
                  <c:v>32.85714285714284</c:v>
                </c:pt>
                <c:pt idx="7">
                  <c:v>30.142857142857149</c:v>
                </c:pt>
                <c:pt idx="8">
                  <c:v>25.857142857142851</c:v>
                </c:pt>
                <c:pt idx="9">
                  <c:v>53.85714285714284</c:v>
                </c:pt>
                <c:pt idx="10">
                  <c:v>31.83333333333331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0522880"/>
        <c:axId val="40524800"/>
      </c:lineChart>
      <c:catAx>
        <c:axId val="4052288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lang="it-IT" sz="11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40524800"/>
        <c:crosses val="autoZero"/>
        <c:auto val="1"/>
        <c:lblAlgn val="ctr"/>
        <c:lblOffset val="100"/>
        <c:noMultiLvlLbl val="0"/>
      </c:catAx>
      <c:valAx>
        <c:axId val="4052480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it-IT" sz="11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40522880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lang="it-IT" sz="1050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rain!$BH$1</c:f>
              <c:strCache>
                <c:ptCount val="1"/>
                <c:pt idx="0">
                  <c:v>2011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val>
            <c:numRef>
              <c:f>rain!$BH$2:$BH$13</c:f>
              <c:numCache>
                <c:formatCode>General</c:formatCode>
                <c:ptCount val="12"/>
                <c:pt idx="0">
                  <c:v>2.2000000000000002</c:v>
                </c:pt>
                <c:pt idx="1">
                  <c:v>1.2</c:v>
                </c:pt>
                <c:pt idx="2">
                  <c:v>12.4</c:v>
                </c:pt>
                <c:pt idx="3">
                  <c:v>11.8</c:v>
                </c:pt>
                <c:pt idx="4">
                  <c:v>22</c:v>
                </c:pt>
                <c:pt idx="5">
                  <c:v>3.4</c:v>
                </c:pt>
                <c:pt idx="6">
                  <c:v>19</c:v>
                </c:pt>
                <c:pt idx="7">
                  <c:v>0</c:v>
                </c:pt>
                <c:pt idx="8">
                  <c:v>0</c:v>
                </c:pt>
                <c:pt idx="9">
                  <c:v>16.600000000000001</c:v>
                </c:pt>
                <c:pt idx="10">
                  <c:v>23.4</c:v>
                </c:pt>
                <c:pt idx="11">
                  <c:v>0</c:v>
                </c:pt>
              </c:numCache>
            </c:numRef>
          </c:val>
        </c:ser>
        <c:ser>
          <c:idx val="2"/>
          <c:order val="1"/>
          <c:tx>
            <c:strRef>
              <c:f>rain!$BI$1</c:f>
              <c:strCache>
                <c:ptCount val="1"/>
                <c:pt idx="0">
                  <c:v>2012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c:spPr>
          <c:invertIfNegative val="0"/>
          <c:val>
            <c:numRef>
              <c:f>rain!$BI$2:$BI$13</c:f>
              <c:numCache>
                <c:formatCode>General</c:formatCode>
                <c:ptCount val="12"/>
                <c:pt idx="0">
                  <c:v>5.8</c:v>
                </c:pt>
                <c:pt idx="1">
                  <c:v>2.6</c:v>
                </c:pt>
                <c:pt idx="2">
                  <c:v>0</c:v>
                </c:pt>
                <c:pt idx="3">
                  <c:v>15.8</c:v>
                </c:pt>
                <c:pt idx="4">
                  <c:v>1.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42.000000000000007</c:v>
                </c:pt>
                <c:pt idx="10">
                  <c:v>0.2</c:v>
                </c:pt>
                <c:pt idx="11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541568"/>
        <c:axId val="40555648"/>
      </c:barChart>
      <c:catAx>
        <c:axId val="4054156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lang="it-IT" sz="11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40555648"/>
        <c:crosses val="autoZero"/>
        <c:auto val="1"/>
        <c:lblAlgn val="ctr"/>
        <c:lblOffset val="100"/>
        <c:noMultiLvlLbl val="0"/>
      </c:catAx>
      <c:valAx>
        <c:axId val="4055564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it-IT" sz="11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40541568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lang="it-IT" sz="1100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B039A9-77E8-468F-8E9B-BECC6D8DC3B2}" type="datetimeFigureOut">
              <a:rPr lang="it-IT"/>
              <a:pPr>
                <a:defRPr/>
              </a:pPr>
              <a:t>23/0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96CD3D-5B6F-4C70-8E3E-E37B7DDAEEDA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4C215D5-7087-4022-A22C-0426744A6DD4}" type="datetimeFigureOut">
              <a:rPr lang="it-IT"/>
              <a:pPr>
                <a:defRPr/>
              </a:pPr>
              <a:t>23/0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7A6DE5-A822-4D2F-A33E-500AB87F00E2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6B1B3C-37A2-4A7D-B9AD-703B0F69E464}" type="datetimeFigureOut">
              <a:rPr lang="it-IT"/>
              <a:pPr>
                <a:defRPr/>
              </a:pPr>
              <a:t>23/0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A2A9BB-A600-46DD-AE6F-4B9CD5A74CE0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967BE5-5AFF-4769-AE9C-281AD1EF728A}" type="datetimeFigureOut">
              <a:rPr lang="it-IT"/>
              <a:pPr>
                <a:defRPr/>
              </a:pPr>
              <a:t>23/0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B70A36-CDAB-4133-894F-7FA2B4CA2E07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E3B7DB-F983-4C93-8A59-E148A5E8D784}" type="datetimeFigureOut">
              <a:rPr lang="it-IT"/>
              <a:pPr>
                <a:defRPr/>
              </a:pPr>
              <a:t>23/0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BCFBD3-619F-4EAF-B0F8-5EE79DFDAF34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C7727D-C072-482A-8182-54C860E899AC}" type="datetimeFigureOut">
              <a:rPr lang="it-IT"/>
              <a:pPr>
                <a:defRPr/>
              </a:pPr>
              <a:t>23/02/2016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96DD13-32D2-4671-9462-3594AD4CC292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F58AC6-C95F-4E31-A164-D67FB6FD6A4F}" type="datetimeFigureOut">
              <a:rPr lang="it-IT"/>
              <a:pPr>
                <a:defRPr/>
              </a:pPr>
              <a:t>23/02/2016</a:t>
            </a:fld>
            <a:endParaRPr lang="it-IT"/>
          </a:p>
        </p:txBody>
      </p:sp>
      <p:sp>
        <p:nvSpPr>
          <p:cNvPr id="8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9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37AD4E-18A9-4E04-AB41-772455003255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E8EA6C-9307-4BA5-B0A8-CE2D4059A537}" type="datetimeFigureOut">
              <a:rPr lang="it-IT"/>
              <a:pPr>
                <a:defRPr/>
              </a:pPr>
              <a:t>23/02/2016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22E331-002D-4F89-BDF5-E03E1BF57468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2F8D42-4ECE-4C53-9A8A-4BCBBCFCEEB1}" type="datetimeFigureOut">
              <a:rPr lang="it-IT"/>
              <a:pPr>
                <a:defRPr/>
              </a:pPr>
              <a:t>23/02/2016</a:t>
            </a:fld>
            <a:endParaRPr lang="it-IT"/>
          </a:p>
        </p:txBody>
      </p:sp>
      <p:sp>
        <p:nvSpPr>
          <p:cNvPr id="3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4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5A7A70-113F-4921-8809-3AAB4823FA18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794C86-867F-4DE2-9FBF-4117E2B2E3F2}" type="datetimeFigureOut">
              <a:rPr lang="it-IT"/>
              <a:pPr>
                <a:defRPr/>
              </a:pPr>
              <a:t>23/02/2016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7AC0AF-2114-41DC-8E37-86C1A9E583A6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2296DE-C926-4BDC-83B8-86E3153B07FE}" type="datetimeFigureOut">
              <a:rPr lang="it-IT"/>
              <a:pPr>
                <a:defRPr/>
              </a:pPr>
              <a:t>23/02/2016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0ADDD2-B84F-448E-99E7-D4F666C39278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egnaposto titolo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/>
              <a:t>Click to edit Master title style</a:t>
            </a:r>
          </a:p>
        </p:txBody>
      </p:sp>
      <p:sp>
        <p:nvSpPr>
          <p:cNvPr id="1027" name="Segnaposto testo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7E8FC7FE-C492-4A29-A6C5-4EE52070EF47}" type="datetimeFigureOut">
              <a:rPr lang="it-IT"/>
              <a:pPr>
                <a:defRPr/>
              </a:pPr>
              <a:t>23/02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729800C2-F279-443F-B56A-8BE735C504BB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72" charset="-128"/>
          <a:cs typeface="ＭＳ Ｐゴシック" pitchFamily="-72" charset="-128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pitchFamily="-72" charset="0"/>
        <a:buChar char="•"/>
        <a:defRPr sz="3200" kern="1200">
          <a:solidFill>
            <a:schemeClr val="tx1"/>
          </a:solidFill>
          <a:latin typeface="+mn-lt"/>
          <a:ea typeface="ＭＳ Ｐゴシック" pitchFamily="-72" charset="-128"/>
          <a:cs typeface="ＭＳ Ｐゴシック" pitchFamily="-72" charset="-128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pitchFamily="-72" charset="0"/>
        <a:buChar char="–"/>
        <a:defRPr sz="28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pitchFamily="-72" charset="0"/>
        <a:buChar char="•"/>
        <a:defRPr sz="24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pitchFamily="-72" charset="0"/>
        <a:buChar char="–"/>
        <a:defRPr sz="20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pitchFamily="-72" charset="0"/>
        <a:buChar char="»"/>
        <a:defRPr sz="20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fico 3"/>
          <p:cNvGraphicFramePr>
            <a:graphicFrameLocks noChangeAspect="1"/>
          </p:cNvGraphicFramePr>
          <p:nvPr/>
        </p:nvGraphicFramePr>
        <p:xfrm>
          <a:off x="252000" y="184666"/>
          <a:ext cx="4320000" cy="32835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afico 4"/>
          <p:cNvGraphicFramePr>
            <a:graphicFrameLocks/>
          </p:cNvGraphicFramePr>
          <p:nvPr/>
        </p:nvGraphicFramePr>
        <p:xfrm>
          <a:off x="4644008" y="260648"/>
          <a:ext cx="4392008" cy="3240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Grafico 5"/>
          <p:cNvGraphicFramePr>
            <a:graphicFrameLocks noChangeAspect="1"/>
          </p:cNvGraphicFramePr>
          <p:nvPr/>
        </p:nvGraphicFramePr>
        <p:xfrm>
          <a:off x="323528" y="3645024"/>
          <a:ext cx="3685449" cy="28083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3316" name="CasellaDiTesto 6"/>
          <p:cNvSpPr txBox="1">
            <a:spLocks noChangeArrowheads="1"/>
          </p:cNvSpPr>
          <p:nvPr/>
        </p:nvSpPr>
        <p:spPr bwMode="auto">
          <a:xfrm>
            <a:off x="11113" y="0"/>
            <a:ext cx="350837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b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A</a:t>
            </a:r>
          </a:p>
        </p:txBody>
      </p:sp>
      <p:sp>
        <p:nvSpPr>
          <p:cNvPr id="13317" name="CasellaDiTesto 7"/>
          <p:cNvSpPr txBox="1">
            <a:spLocks noChangeArrowheads="1"/>
          </p:cNvSpPr>
          <p:nvPr/>
        </p:nvSpPr>
        <p:spPr bwMode="auto">
          <a:xfrm>
            <a:off x="4572000" y="0"/>
            <a:ext cx="350838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b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B</a:t>
            </a:r>
          </a:p>
        </p:txBody>
      </p:sp>
      <p:sp>
        <p:nvSpPr>
          <p:cNvPr id="13318" name="CasellaDiTesto 8"/>
          <p:cNvSpPr txBox="1">
            <a:spLocks noChangeArrowheads="1"/>
          </p:cNvSpPr>
          <p:nvPr/>
        </p:nvSpPr>
        <p:spPr bwMode="auto">
          <a:xfrm>
            <a:off x="0" y="3429000"/>
            <a:ext cx="350838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b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C</a:t>
            </a:r>
          </a:p>
        </p:txBody>
      </p:sp>
      <p:sp>
        <p:nvSpPr>
          <p:cNvPr id="13319" name="CasellaDiTesto 9"/>
          <p:cNvSpPr txBox="1">
            <a:spLocks noChangeArrowheads="1"/>
          </p:cNvSpPr>
          <p:nvPr/>
        </p:nvSpPr>
        <p:spPr bwMode="auto">
          <a:xfrm rot="-5400000">
            <a:off x="-404018" y="2042319"/>
            <a:ext cx="1270000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1100" b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Temperature (°C)</a:t>
            </a:r>
          </a:p>
        </p:txBody>
      </p:sp>
      <p:sp>
        <p:nvSpPr>
          <p:cNvPr id="13320" name="CasellaDiTesto 10"/>
          <p:cNvSpPr txBox="1">
            <a:spLocks noChangeArrowheads="1"/>
          </p:cNvSpPr>
          <p:nvPr/>
        </p:nvSpPr>
        <p:spPr bwMode="auto">
          <a:xfrm rot="-5400000">
            <a:off x="3861594" y="1921669"/>
            <a:ext cx="1519238" cy="260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1100" b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Relative humidity (%)</a:t>
            </a:r>
          </a:p>
        </p:txBody>
      </p:sp>
      <p:sp>
        <p:nvSpPr>
          <p:cNvPr id="13321" name="CasellaDiTesto 11"/>
          <p:cNvSpPr txBox="1">
            <a:spLocks noChangeArrowheads="1"/>
          </p:cNvSpPr>
          <p:nvPr/>
        </p:nvSpPr>
        <p:spPr bwMode="auto">
          <a:xfrm rot="-5400000">
            <a:off x="-197644" y="4996657"/>
            <a:ext cx="836613" cy="260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1100" b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Rain (mm)</a:t>
            </a:r>
          </a:p>
        </p:txBody>
      </p:sp>
      <p:sp>
        <p:nvSpPr>
          <p:cNvPr id="13322" name="CasellaDiTesto 12"/>
          <p:cNvSpPr txBox="1">
            <a:spLocks noChangeArrowheads="1"/>
          </p:cNvSpPr>
          <p:nvPr/>
        </p:nvSpPr>
        <p:spPr bwMode="auto">
          <a:xfrm>
            <a:off x="1763713" y="3430588"/>
            <a:ext cx="490537" cy="26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1100" b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week</a:t>
            </a:r>
          </a:p>
        </p:txBody>
      </p:sp>
      <p:sp>
        <p:nvSpPr>
          <p:cNvPr id="13323" name="CasellaDiTesto 13"/>
          <p:cNvSpPr txBox="1">
            <a:spLocks noChangeArrowheads="1"/>
          </p:cNvSpPr>
          <p:nvPr/>
        </p:nvSpPr>
        <p:spPr bwMode="auto">
          <a:xfrm>
            <a:off x="6516688" y="3429000"/>
            <a:ext cx="490537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1100" b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week</a:t>
            </a:r>
          </a:p>
        </p:txBody>
      </p:sp>
      <p:sp>
        <p:nvSpPr>
          <p:cNvPr id="13324" name="CasellaDiTesto 14"/>
          <p:cNvSpPr txBox="1">
            <a:spLocks noChangeArrowheads="1"/>
          </p:cNvSpPr>
          <p:nvPr/>
        </p:nvSpPr>
        <p:spPr bwMode="auto">
          <a:xfrm>
            <a:off x="1763713" y="6372225"/>
            <a:ext cx="490537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it-IT" sz="1100" b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week</a:t>
            </a:r>
          </a:p>
        </p:txBody>
      </p:sp>
      <p:sp>
        <p:nvSpPr>
          <p:cNvPr id="13325" name="CasellaDiTesto 15"/>
          <p:cNvSpPr txBox="1">
            <a:spLocks noChangeArrowheads="1"/>
          </p:cNvSpPr>
          <p:nvPr/>
        </p:nvSpPr>
        <p:spPr bwMode="auto">
          <a:xfrm>
            <a:off x="4748213" y="4175125"/>
            <a:ext cx="4283075" cy="1200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just"/>
            <a:r>
              <a:rPr lang="it-IT" sz="1200" b="1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Figure S1: </a:t>
            </a:r>
            <a:r>
              <a:rPr lang="it-IT" sz="1200" dirty="0" err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Weekly</a:t>
            </a:r>
            <a:r>
              <a:rPr lang="it-IT" sz="1200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 </a:t>
            </a:r>
            <a:r>
              <a:rPr lang="it-IT" sz="1200" dirty="0" err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means</a:t>
            </a:r>
            <a:r>
              <a:rPr lang="it-IT" sz="1200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 of </a:t>
            </a:r>
            <a:r>
              <a:rPr lang="it-IT" sz="1200" b="1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A) </a:t>
            </a:r>
            <a:r>
              <a:rPr lang="it-IT" sz="1200" dirty="0" smtClean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temperature, </a:t>
            </a:r>
            <a:r>
              <a:rPr lang="it-IT" sz="1200" b="1" dirty="0" smtClean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B</a:t>
            </a:r>
            <a:r>
              <a:rPr lang="it-IT" sz="1200" b="1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) </a:t>
            </a:r>
            <a:r>
              <a:rPr lang="it-IT" sz="1200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relative </a:t>
            </a:r>
            <a:r>
              <a:rPr lang="it-IT" sz="1200" dirty="0" err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humidity</a:t>
            </a:r>
            <a:r>
              <a:rPr lang="it-IT" sz="1200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 and </a:t>
            </a:r>
            <a:r>
              <a:rPr lang="it-IT" sz="1200" b="1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C) </a:t>
            </a:r>
            <a:r>
              <a:rPr lang="it-IT" sz="1200" dirty="0" err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weekly</a:t>
            </a:r>
            <a:r>
              <a:rPr lang="it-IT" sz="1200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 </a:t>
            </a:r>
            <a:r>
              <a:rPr lang="it-IT" sz="1200" dirty="0" err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sums</a:t>
            </a:r>
            <a:r>
              <a:rPr lang="it-IT" sz="1200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 of </a:t>
            </a:r>
            <a:r>
              <a:rPr lang="it-IT" sz="1200" dirty="0" err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rain</a:t>
            </a:r>
            <a:r>
              <a:rPr lang="it-IT" sz="1200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 </a:t>
            </a:r>
            <a:r>
              <a:rPr lang="it-IT" sz="1200" dirty="0" err="1" smtClean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precipitation</a:t>
            </a:r>
            <a:r>
              <a:rPr lang="it-IT" sz="1200" dirty="0" smtClean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 </a:t>
            </a:r>
            <a:r>
              <a:rPr lang="it-IT" sz="1200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in </a:t>
            </a:r>
            <a:r>
              <a:rPr lang="it-IT" sz="1200" dirty="0" err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years</a:t>
            </a:r>
            <a:r>
              <a:rPr lang="it-IT" sz="1200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 2011 and 2012. First week </a:t>
            </a:r>
            <a:r>
              <a:rPr lang="it-IT" sz="1200" dirty="0" err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corresponds</a:t>
            </a:r>
            <a:r>
              <a:rPr lang="it-IT" sz="1200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 to the first </a:t>
            </a:r>
            <a:r>
              <a:rPr lang="it-IT" sz="1200" dirty="0" err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seven</a:t>
            </a:r>
            <a:r>
              <a:rPr lang="it-IT" sz="1200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 </a:t>
            </a:r>
            <a:r>
              <a:rPr lang="it-IT" sz="1200" dirty="0" err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days</a:t>
            </a:r>
            <a:r>
              <a:rPr lang="it-IT" sz="1200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 of </a:t>
            </a:r>
            <a:r>
              <a:rPr lang="it-IT" sz="1200" dirty="0" err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flowering</a:t>
            </a:r>
            <a:r>
              <a:rPr lang="it-IT" sz="1200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 in the </a:t>
            </a:r>
            <a:r>
              <a:rPr lang="it-IT" sz="1200" dirty="0" err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early</a:t>
            </a:r>
            <a:r>
              <a:rPr lang="it-IT" sz="1200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 </a:t>
            </a:r>
            <a:r>
              <a:rPr lang="it-IT" sz="1200" dirty="0" err="1" smtClean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sowing</a:t>
            </a:r>
            <a:r>
              <a:rPr lang="it-IT" sz="1200" dirty="0" smtClean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 </a:t>
            </a:r>
            <a:r>
              <a:rPr lang="it-IT" sz="1200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of </a:t>
            </a:r>
            <a:r>
              <a:rPr lang="it-IT" sz="1200" dirty="0" err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both</a:t>
            </a:r>
            <a:r>
              <a:rPr lang="it-IT" sz="1200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 2011 and 2012. Last week </a:t>
            </a:r>
            <a:r>
              <a:rPr lang="it-IT" sz="1200" dirty="0" err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corresponds</a:t>
            </a:r>
            <a:r>
              <a:rPr lang="it-IT" sz="1200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 to the week of the </a:t>
            </a:r>
            <a:r>
              <a:rPr lang="it-IT" sz="1200" dirty="0" err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harvest</a:t>
            </a:r>
            <a:r>
              <a:rPr lang="it-IT" sz="1200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 </a:t>
            </a:r>
            <a:r>
              <a:rPr lang="it-IT" sz="1200" dirty="0" err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day</a:t>
            </a:r>
            <a:r>
              <a:rPr lang="it-IT" sz="1200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 for </a:t>
            </a:r>
            <a:r>
              <a:rPr lang="it-IT" sz="1200" dirty="0" err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both</a:t>
            </a:r>
            <a:r>
              <a:rPr lang="it-IT" sz="1200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 2011 and 2012, in the </a:t>
            </a:r>
            <a:r>
              <a:rPr lang="it-IT" sz="1200" dirty="0" err="1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early</a:t>
            </a:r>
            <a:r>
              <a:rPr lang="it-IT" sz="1200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 </a:t>
            </a:r>
            <a:r>
              <a:rPr lang="it-IT" sz="1200" dirty="0" smtClean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and </a:t>
            </a:r>
            <a:r>
              <a:rPr lang="it-IT" sz="1200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late </a:t>
            </a:r>
            <a:r>
              <a:rPr lang="it-IT" sz="1200" dirty="0" err="1" smtClean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sowings</a:t>
            </a:r>
            <a:r>
              <a:rPr lang="it-IT" sz="1200" dirty="0">
                <a:latin typeface="Times New Roman" pitchFamily="-72" charset="0"/>
                <a:ea typeface="Times New Roman" pitchFamily="-72" charset="0"/>
                <a:cs typeface="Times New Roman" pitchFamily="-72" charset="0"/>
              </a:rPr>
              <a:t>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</TotalTime>
  <Words>88</Words>
  <Application>Microsoft Office PowerPoint</Application>
  <PresentationFormat>Presentazione su schermo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Company>Università Cattolica del Sacro Cuore - Piacenz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ist.maroccolab-pc</dc:creator>
  <cp:lastModifiedBy>ist.maroccolab-pc</cp:lastModifiedBy>
  <cp:revision>13</cp:revision>
  <cp:lastPrinted>2015-11-20T15:21:19Z</cp:lastPrinted>
  <dcterms:created xsi:type="dcterms:W3CDTF">2015-11-20T14:14:40Z</dcterms:created>
  <dcterms:modified xsi:type="dcterms:W3CDTF">2016-02-23T08:43:48Z</dcterms:modified>
</cp:coreProperties>
</file>